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5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58"/>
    <p:restoredTop sz="94694"/>
  </p:normalViewPr>
  <p:slideViewPr>
    <p:cSldViewPr snapToGrid="0" snapToObjects="1">
      <p:cViewPr varScale="1">
        <p:scale>
          <a:sx n="72" d="100"/>
          <a:sy n="72" d="100"/>
        </p:scale>
        <p:origin x="42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6D70FE-D04C-2048-9801-23B6AFD26AFB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83B33-315C-CA47-AB6D-3D1E8EBFF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3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/>
              <a:t>Make significance markers larger and move away from bars</a:t>
            </a:r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B16194-2E0C-8A41-BC97-80E122E0C6E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525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DFFB-97FA-7F43-B102-5D7EEC4964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6F0EE-6CD2-C14A-BFFE-CCD041524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EEC63-325C-764E-9BAC-07192CB43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9F860-C48C-4E4B-BE39-7F9C8C9E8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959C-5A7A-7641-AAD0-AEF2D47C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0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6DE9C-A47C-C344-8D97-FF3241E5E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EE354-EE4C-0644-8868-D524C8FA8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683B37-EBE0-5C47-8E27-D79A136E4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CBD3C-11FE-684E-B09F-0EBE6DF1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3275B-7C20-B64D-B818-FD6325D3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5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6F920-B418-E94F-8C57-BE2BF44679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D64F-CEFD-CC45-AE6F-172C6B2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A86A7-3ABE-8B48-B503-59754C78C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25CE-88ED-A742-94EF-B702A8CE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6D06F-A0BC-BE48-969A-0A875FF30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AC2D3-DF5F-9C42-AE01-A8A1C0F5A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0112-8A20-CC41-A1B2-A87DEB85A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0FF51-6968-C34F-8AE0-23A0D3B80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725F5-04DB-2E42-8682-27B9DDEAA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46B48-EC16-2349-9651-9E54593F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4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A38BF-6026-1A4D-BB3E-867FA06D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28CFF-2EC9-E04B-884B-39C918DCB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E706-F3F3-C740-87BC-A45F26CB9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8E9D9-74E6-9C41-A2AC-D35B0F2A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CBD2F-A841-D64F-A882-832567A9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9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D65C-5A66-654E-AF6E-45918FC9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99CEA5-787A-7348-8841-918DF30D4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AE10EA-10FA-A545-8766-1AF83CEF3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31EA-65E5-7D44-93CA-51E686094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E453A-63A6-8B45-ACA5-FD2D86D8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3164D-8B40-1B40-A6D1-94E4FA81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6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D3BD-5AA1-DA43-9A5B-EDEC2C27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3EBA-49CC-1E44-8A56-66A62E466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C3D158-F8CD-AA4A-9081-2F199FCB3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C2DF29-98D4-E642-AABF-87B86B8D6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236C32-6DCE-7842-A7D1-C25154EB56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324436-DCEA-1A42-9523-EFB7547E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751D9F-F282-B34A-B40A-68C64893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1AFED-E232-1E48-B3FE-958A1AED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3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36C5-EBCF-AF4E-B717-D3097384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0E53A5-F46A-1349-83D4-92BEFD5D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BB9AC-B442-D444-9908-5DC62026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8D2F1-37FC-D640-ACD0-5A3AE911C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63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1565A-3178-C047-A926-B04E64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FA3EF3-8587-FD4C-AD8B-C13DA0DF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DFD632-3D49-EF43-BF1A-7925B033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3A4D7-C34C-DC47-B63E-BDF4C180B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A8B74-36CC-D749-8819-1BC994BE50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1896E-DCA4-6845-923C-ACDA14B8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8438B-54F5-C74B-9D4D-B47503EF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71803-D363-E844-AF56-D592DFADB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5E1AB-ACF2-7646-8CF9-FFE0C0AC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3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8548F-3318-B244-9115-C52BB0D4A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DCEDCF-4BF1-5645-8D37-84C92E930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129E3-24DA-0246-957F-D77AB3033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FDF5F-BD1F-6642-AB13-5CCA37DE3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40D98-5EF3-A94A-8640-7EB1C90D9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0A631D-6DBD-F34C-9D8D-01FF5403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24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764737-EB93-594F-AFC1-EA8B1A707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C0B1C-B5AF-D24B-A033-E4A79E376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CDBCD-4181-B348-B10A-5797FD2654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18C69-043C-224C-9F27-60A824A9B4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3F78-65F1-A447-AF4E-FF7E84055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0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C888A96-2CF9-413D-95C1-D219260033EB}"/>
              </a:ext>
            </a:extLst>
          </p:cNvPr>
          <p:cNvGrpSpPr/>
          <p:nvPr/>
        </p:nvGrpSpPr>
        <p:grpSpPr>
          <a:xfrm>
            <a:off x="0" y="540923"/>
            <a:ext cx="4604332" cy="6317077"/>
            <a:chOff x="1772204" y="481126"/>
            <a:chExt cx="4604332" cy="6317077"/>
          </a:xfrm>
        </p:grpSpPr>
        <p:sp>
          <p:nvSpPr>
            <p:cNvPr id="25" name="Rectangle 24"/>
            <p:cNvSpPr/>
            <p:nvPr/>
          </p:nvSpPr>
          <p:spPr>
            <a:xfrm>
              <a:off x="2516394" y="2024241"/>
              <a:ext cx="3683108" cy="115570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3849210" y="1268501"/>
              <a:ext cx="1158205" cy="38964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/>
                <a:t>Control 30</a:t>
              </a:r>
            </a:p>
            <a:p>
              <a:pPr algn="r"/>
              <a:r>
                <a:rPr lang="en-US" sz="1000" dirty="0"/>
                <a:t>IL-1β 30</a:t>
              </a:r>
            </a:p>
            <a:p>
              <a:pPr algn="r"/>
              <a:r>
                <a:rPr lang="en-US" sz="1000" dirty="0"/>
                <a:t>P4 30</a:t>
              </a:r>
            </a:p>
            <a:p>
              <a:pPr algn="r"/>
              <a:r>
                <a:rPr lang="en-US" sz="1000" dirty="0"/>
                <a:t>F 30</a:t>
              </a:r>
            </a:p>
            <a:p>
              <a:pPr algn="r"/>
              <a:r>
                <a:rPr lang="en-US" sz="1000" dirty="0"/>
                <a:t>F+IL-1β 30</a:t>
              </a:r>
            </a:p>
            <a:p>
              <a:pPr algn="r"/>
              <a:r>
                <a:rPr lang="en-US" sz="1000" dirty="0"/>
                <a:t>P4+IL-1β 30</a:t>
              </a:r>
            </a:p>
            <a:p>
              <a:pPr algn="r"/>
              <a:r>
                <a:rPr lang="en-US" sz="1000" dirty="0"/>
                <a:t>P4+F 30</a:t>
              </a:r>
            </a:p>
            <a:p>
              <a:pPr algn="r"/>
              <a:r>
                <a:rPr lang="en-US" sz="1000" dirty="0"/>
                <a:t>P4+F+IL-1β 30</a:t>
              </a:r>
            </a:p>
            <a:p>
              <a:pPr algn="r"/>
              <a:r>
                <a:rPr lang="en-US" sz="1000" b="1" dirty="0"/>
                <a:t>Control 60</a:t>
              </a:r>
            </a:p>
            <a:p>
              <a:pPr algn="r"/>
              <a:r>
                <a:rPr lang="en-US" sz="1000" dirty="0"/>
                <a:t>IL-1β 60</a:t>
              </a:r>
            </a:p>
            <a:p>
              <a:pPr algn="r"/>
              <a:r>
                <a:rPr lang="en-US" sz="1000" dirty="0"/>
                <a:t>P4 60</a:t>
              </a:r>
            </a:p>
            <a:p>
              <a:pPr algn="r"/>
              <a:r>
                <a:rPr lang="en-US" sz="1000" dirty="0"/>
                <a:t>F 60</a:t>
              </a:r>
            </a:p>
            <a:p>
              <a:pPr algn="r"/>
              <a:r>
                <a:rPr lang="en-US" sz="1000" dirty="0"/>
                <a:t>F+IL-1β 60</a:t>
              </a:r>
            </a:p>
            <a:p>
              <a:pPr algn="r"/>
              <a:r>
                <a:rPr lang="en-US" sz="1000" dirty="0"/>
                <a:t>P4+IL-1β 60</a:t>
              </a:r>
            </a:p>
            <a:p>
              <a:pPr algn="r"/>
              <a:r>
                <a:rPr lang="en-US" sz="1000" dirty="0"/>
                <a:t>P4+F 60</a:t>
              </a:r>
            </a:p>
            <a:p>
              <a:pPr algn="r"/>
              <a:r>
                <a:rPr lang="en-US" sz="1000" dirty="0"/>
                <a:t>P4+F+IL-1β 60</a:t>
              </a:r>
            </a:p>
            <a:p>
              <a:pPr algn="r"/>
              <a:r>
                <a:rPr lang="en-US" sz="1000" b="1" dirty="0"/>
                <a:t>Control 120</a:t>
              </a:r>
            </a:p>
            <a:p>
              <a:pPr algn="r"/>
              <a:r>
                <a:rPr lang="en-US" sz="1000" dirty="0"/>
                <a:t>IL-1β 120</a:t>
              </a:r>
            </a:p>
            <a:p>
              <a:pPr algn="r"/>
              <a:r>
                <a:rPr lang="en-US" sz="1000" dirty="0"/>
                <a:t>P4 120</a:t>
              </a:r>
            </a:p>
            <a:p>
              <a:pPr algn="r"/>
              <a:r>
                <a:rPr lang="en-US" sz="1000" dirty="0"/>
                <a:t>F 120</a:t>
              </a:r>
            </a:p>
            <a:p>
              <a:pPr algn="r"/>
              <a:r>
                <a:rPr lang="en-US" sz="1000" dirty="0"/>
                <a:t>F+IL-1β 120</a:t>
              </a:r>
            </a:p>
            <a:p>
              <a:pPr algn="r"/>
              <a:r>
                <a:rPr lang="en-US" sz="1000" dirty="0"/>
                <a:t>P4+IL-1β 120</a:t>
              </a:r>
            </a:p>
            <a:p>
              <a:pPr algn="r"/>
              <a:r>
                <a:rPr lang="en-US" sz="1000" dirty="0"/>
                <a:t>P4+F 120</a:t>
              </a:r>
            </a:p>
            <a:p>
              <a:pPr algn="r"/>
              <a:r>
                <a:rPr lang="en-US" sz="1000" dirty="0"/>
                <a:t>P4+F+IL-1β 120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946523" y="2012945"/>
              <a:ext cx="6007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KP-1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72204" y="2327803"/>
              <a:ext cx="764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α-tubulin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32081" y="3635902"/>
              <a:ext cx="27879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B                      Cytosolic IKBα</a:t>
              </a: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2536880" y="5052017"/>
              <a:ext cx="3683108" cy="1155700"/>
            </a:xfrm>
            <a:prstGeom prst="rect">
              <a:avLst/>
            </a:prstGeom>
            <a:solidFill>
              <a:srgbClr val="FFFFFF"/>
            </a:solidFill>
            <a:ln>
              <a:solidFill>
                <a:srgbClr val="FFFFFF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3" name="TextBox 32"/>
            <p:cNvSpPr txBox="1"/>
            <p:nvPr/>
          </p:nvSpPr>
          <p:spPr>
            <a:xfrm rot="16200000">
              <a:off x="3806196" y="4270877"/>
              <a:ext cx="1158205" cy="389644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/>
                <a:t>Control 30</a:t>
              </a:r>
            </a:p>
            <a:p>
              <a:pPr algn="r"/>
              <a:r>
                <a:rPr lang="en-US" sz="1000" dirty="0"/>
                <a:t>IL-1β 30</a:t>
              </a:r>
            </a:p>
            <a:p>
              <a:pPr algn="r"/>
              <a:r>
                <a:rPr lang="en-US" sz="1000" dirty="0"/>
                <a:t>P4 30</a:t>
              </a:r>
            </a:p>
            <a:p>
              <a:pPr algn="r"/>
              <a:r>
                <a:rPr lang="en-US" sz="1000" dirty="0"/>
                <a:t>F 30</a:t>
              </a:r>
            </a:p>
            <a:p>
              <a:pPr algn="r"/>
              <a:r>
                <a:rPr lang="en-US" sz="1000" dirty="0"/>
                <a:t>F+IL-1β 30</a:t>
              </a:r>
            </a:p>
            <a:p>
              <a:pPr algn="r"/>
              <a:r>
                <a:rPr lang="en-US" sz="1000" dirty="0"/>
                <a:t>P4+IL-1β 30</a:t>
              </a:r>
            </a:p>
            <a:p>
              <a:pPr algn="r"/>
              <a:r>
                <a:rPr lang="en-US" sz="1000" dirty="0"/>
                <a:t>P4+F 30</a:t>
              </a:r>
            </a:p>
            <a:p>
              <a:pPr algn="r"/>
              <a:r>
                <a:rPr lang="en-US" sz="1000" dirty="0"/>
                <a:t>P4+F+IL-1β 30</a:t>
              </a:r>
            </a:p>
            <a:p>
              <a:pPr algn="r"/>
              <a:r>
                <a:rPr lang="en-US" sz="1000" b="1" dirty="0"/>
                <a:t>Control 60</a:t>
              </a:r>
            </a:p>
            <a:p>
              <a:pPr algn="r"/>
              <a:r>
                <a:rPr lang="en-US" sz="1000" dirty="0"/>
                <a:t>IL-1β 60</a:t>
              </a:r>
            </a:p>
            <a:p>
              <a:pPr algn="r"/>
              <a:r>
                <a:rPr lang="en-US" sz="1000" dirty="0"/>
                <a:t>P4 60</a:t>
              </a:r>
            </a:p>
            <a:p>
              <a:pPr algn="r"/>
              <a:r>
                <a:rPr lang="en-US" sz="1000" dirty="0"/>
                <a:t>F 60</a:t>
              </a:r>
            </a:p>
            <a:p>
              <a:pPr algn="r"/>
              <a:r>
                <a:rPr lang="en-US" sz="1000" dirty="0"/>
                <a:t>F+IL-1β 60</a:t>
              </a:r>
            </a:p>
            <a:p>
              <a:pPr algn="r"/>
              <a:r>
                <a:rPr lang="en-US" sz="1000" dirty="0"/>
                <a:t>P4+IL-1β 60</a:t>
              </a:r>
            </a:p>
            <a:p>
              <a:pPr algn="r"/>
              <a:r>
                <a:rPr lang="en-US" sz="1000" dirty="0"/>
                <a:t>P4+F 60</a:t>
              </a:r>
            </a:p>
            <a:p>
              <a:pPr algn="r"/>
              <a:r>
                <a:rPr lang="en-US" sz="1000" dirty="0"/>
                <a:t>P4+F+IL-1β 60</a:t>
              </a:r>
            </a:p>
            <a:p>
              <a:pPr algn="r"/>
              <a:r>
                <a:rPr lang="en-US" sz="1000" b="1" dirty="0"/>
                <a:t>Control 120</a:t>
              </a:r>
            </a:p>
            <a:p>
              <a:pPr algn="r"/>
              <a:r>
                <a:rPr lang="en-US" sz="1000" dirty="0"/>
                <a:t>IL-1β 120</a:t>
              </a:r>
            </a:p>
            <a:p>
              <a:pPr algn="r"/>
              <a:r>
                <a:rPr lang="en-US" sz="1000" dirty="0"/>
                <a:t>P4 120</a:t>
              </a:r>
            </a:p>
            <a:p>
              <a:pPr algn="r"/>
              <a:r>
                <a:rPr lang="en-US" sz="1000" dirty="0"/>
                <a:t>F 120</a:t>
              </a:r>
            </a:p>
            <a:p>
              <a:pPr algn="r"/>
              <a:r>
                <a:rPr lang="en-US" sz="1000" dirty="0"/>
                <a:t>F+IL-1β 120</a:t>
              </a:r>
            </a:p>
            <a:p>
              <a:pPr algn="r"/>
              <a:r>
                <a:rPr lang="en-US" sz="1000" dirty="0"/>
                <a:t>P4+IL-1β 120</a:t>
              </a:r>
            </a:p>
            <a:p>
              <a:pPr algn="r"/>
              <a:r>
                <a:rPr lang="en-US" sz="1000" dirty="0"/>
                <a:t>P4+F 120</a:t>
              </a:r>
            </a:p>
            <a:p>
              <a:pPr algn="r"/>
              <a:r>
                <a:rPr lang="en-US" sz="1000" dirty="0"/>
                <a:t>P4+F+IL-1β 120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068608" y="5040721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IKBα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792690" y="5317479"/>
              <a:ext cx="76467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α-tubulin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462474" y="2024242"/>
              <a:ext cx="3757514" cy="651479"/>
            </a:xfrm>
            <a:prstGeom prst="rect">
              <a:avLst/>
            </a:prstGeom>
          </p:spPr>
        </p:pic>
        <p:cxnSp>
          <p:nvCxnSpPr>
            <p:cNvPr id="7" name="Straight Connector 6"/>
            <p:cNvCxnSpPr/>
            <p:nvPr/>
          </p:nvCxnSpPr>
          <p:spPr>
            <a:xfrm>
              <a:off x="4994623" y="2038344"/>
              <a:ext cx="0" cy="6373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>
              <a:off x="3750023" y="2059914"/>
              <a:ext cx="0" cy="63737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90994" y="5064717"/>
              <a:ext cx="3643106" cy="592010"/>
            </a:xfrm>
            <a:prstGeom prst="rect">
              <a:avLst/>
            </a:prstGeom>
          </p:spPr>
        </p:pic>
        <p:cxnSp>
          <p:nvCxnSpPr>
            <p:cNvPr id="41" name="Straight Connector 40"/>
            <p:cNvCxnSpPr/>
            <p:nvPr/>
          </p:nvCxnSpPr>
          <p:spPr>
            <a:xfrm>
              <a:off x="3737323" y="5064717"/>
              <a:ext cx="0" cy="5920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/>
            <p:cNvCxnSpPr/>
            <p:nvPr/>
          </p:nvCxnSpPr>
          <p:spPr>
            <a:xfrm>
              <a:off x="4969223" y="5064718"/>
              <a:ext cx="0" cy="57527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22608" y="4005235"/>
              <a:ext cx="3871980" cy="1059483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22610" y="766766"/>
              <a:ext cx="3897379" cy="1271578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2211595" y="481126"/>
              <a:ext cx="29768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                      Cytosolic MKP-1</a:t>
              </a:r>
            </a:p>
          </p:txBody>
        </p:sp>
      </p:grpSp>
      <p:sp>
        <p:nvSpPr>
          <p:cNvPr id="21" name="Rectangle 264">
            <a:extLst>
              <a:ext uri="{FF2B5EF4-FFF2-40B4-BE49-F238E27FC236}">
                <a16:creationId xmlns:a16="http://schemas.microsoft.com/office/drawing/2014/main" id="{FB444912-BB6C-4128-8578-1F54C2B9B4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864" y="127830"/>
            <a:ext cx="116859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2000" b="1">
                <a:solidFill>
                  <a:srgbClr val="000000"/>
                </a:solidFill>
                <a:latin typeface="Arial Bold" panose="020B0704020202020204" pitchFamily="34" charset="0"/>
              </a:rPr>
              <a:t>S7 Figure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3422750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3</TotalTime>
  <Words>178</Words>
  <Application>Microsoft Office PowerPoint</Application>
  <PresentationFormat>Widescreen</PresentationFormat>
  <Paragraphs>5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old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Mark R</dc:creator>
  <cp:lastModifiedBy>DELL</cp:lastModifiedBy>
  <cp:revision>29</cp:revision>
  <dcterms:created xsi:type="dcterms:W3CDTF">2019-10-13T09:04:07Z</dcterms:created>
  <dcterms:modified xsi:type="dcterms:W3CDTF">2020-11-19T09:04:35Z</dcterms:modified>
</cp:coreProperties>
</file>